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2" r:id="rId3"/>
    <p:sldId id="258" r:id="rId4"/>
    <p:sldId id="259" r:id="rId5"/>
    <p:sldId id="260" r:id="rId6"/>
    <p:sldId id="268" r:id="rId7"/>
    <p:sldId id="267" r:id="rId8"/>
    <p:sldId id="265" r:id="rId9"/>
    <p:sldId id="266" r:id="rId10"/>
    <p:sldId id="263" r:id="rId11"/>
    <p:sldId id="264" r:id="rId12"/>
    <p:sldId id="279" r:id="rId13"/>
    <p:sldId id="278" r:id="rId14"/>
    <p:sldId id="277" r:id="rId15"/>
    <p:sldId id="276" r:id="rId16"/>
    <p:sldId id="275" r:id="rId17"/>
    <p:sldId id="274" r:id="rId18"/>
    <p:sldId id="273" r:id="rId19"/>
    <p:sldId id="272" r:id="rId20"/>
    <p:sldId id="271" r:id="rId21"/>
    <p:sldId id="270" r:id="rId22"/>
    <p:sldId id="269" r:id="rId23"/>
    <p:sldId id="261" r:id="rId24"/>
    <p:sldId id="262" r:id="rId25"/>
    <p:sldId id="280" r:id="rId2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549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228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848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849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696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326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977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191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945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361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066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F884FA-7E72-4ECE-ADF3-D7A262F0A011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002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7800" y="1447800"/>
            <a:ext cx="5364163" cy="6461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855444" y="2438400"/>
            <a:ext cx="4593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ocation </a:t>
            </a:r>
            <a:r>
              <a:rPr lang="en-US" smtClean="0"/>
              <a:t>of BRE </a:t>
            </a:r>
            <a:r>
              <a:rPr lang="en-US" dirty="0" smtClean="0"/>
              <a:t>Elements in the Core Promote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87569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9275"/>
            <a:ext cx="5411787" cy="576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339579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0225"/>
            <a:ext cx="5413375" cy="5800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375334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06413"/>
            <a:ext cx="5413375" cy="58499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158468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25463"/>
            <a:ext cx="5413375" cy="5811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492753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175" y="549275"/>
            <a:ext cx="5327650" cy="576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618652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54038"/>
            <a:ext cx="5413375" cy="5753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62696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11175"/>
            <a:ext cx="5411787" cy="5838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32441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0225"/>
            <a:ext cx="5413375" cy="5800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36251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58800"/>
            <a:ext cx="5413375" cy="5743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736027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8650" y="492125"/>
            <a:ext cx="5346700" cy="5876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752388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9275"/>
            <a:ext cx="5411787" cy="576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486268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9750"/>
            <a:ext cx="5413375" cy="5781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020031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452438"/>
            <a:ext cx="5413375" cy="5957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429882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175" y="554038"/>
            <a:ext cx="5327650" cy="5753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894919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82613"/>
            <a:ext cx="5413375" cy="5695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76205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175" y="534988"/>
            <a:ext cx="5327650" cy="5792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143064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175" y="534988"/>
            <a:ext cx="5327650" cy="5792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92730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4513"/>
            <a:ext cx="5411787" cy="5772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95231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0225"/>
            <a:ext cx="5413375" cy="5802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026516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25463"/>
            <a:ext cx="5413375" cy="5811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350162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4988"/>
            <a:ext cx="5413375" cy="57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376024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68325"/>
            <a:ext cx="5411787" cy="5724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431030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4988"/>
            <a:ext cx="5413375" cy="57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930129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175" y="568325"/>
            <a:ext cx="5327650" cy="5724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789760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6</TotalTime>
  <Words>8</Words>
  <Application>Microsoft Office PowerPoint</Application>
  <PresentationFormat>On-screen Show (4:3)</PresentationFormat>
  <Paragraphs>1</Paragraphs>
  <Slides>2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5</vt:i4>
      </vt:variant>
    </vt:vector>
  </HeadingPairs>
  <TitlesOfParts>
    <vt:vector size="2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y Brown</dc:creator>
  <cp:lastModifiedBy>Jay Brown</cp:lastModifiedBy>
  <cp:revision>89</cp:revision>
  <dcterms:created xsi:type="dcterms:W3CDTF">2017-07-17T14:27:03Z</dcterms:created>
  <dcterms:modified xsi:type="dcterms:W3CDTF">2017-12-10T16:10:10Z</dcterms:modified>
</cp:coreProperties>
</file>